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12192000" cy="190801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28" d="100"/>
          <a:sy n="28" d="100"/>
        </p:scale>
        <p:origin x="2726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122612"/>
            <a:ext cx="10363200" cy="6642723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10021504"/>
            <a:ext cx="9144000" cy="4606621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C96D-EB8A-4052-8474-F05DE77A4B07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6C88B-2928-4EEF-811F-F22292A73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3517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C96D-EB8A-4052-8474-F05DE77A4B07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6C88B-2928-4EEF-811F-F22292A73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796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1015842"/>
            <a:ext cx="2628900" cy="1616955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1015842"/>
            <a:ext cx="7734300" cy="1616955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C96D-EB8A-4052-8474-F05DE77A4B07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6C88B-2928-4EEF-811F-F22292A73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672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C96D-EB8A-4052-8474-F05DE77A4B07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6C88B-2928-4EEF-811F-F22292A73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2131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756796"/>
            <a:ext cx="10515600" cy="7936816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2768698"/>
            <a:ext cx="10515600" cy="417378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C96D-EB8A-4052-8474-F05DE77A4B07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6C88B-2928-4EEF-811F-F22292A73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605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5079210"/>
            <a:ext cx="5181600" cy="121061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5079210"/>
            <a:ext cx="5181600" cy="121061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C96D-EB8A-4052-8474-F05DE77A4B07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6C88B-2928-4EEF-811F-F22292A73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2350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15846"/>
            <a:ext cx="10515600" cy="3687950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4677291"/>
            <a:ext cx="5157787" cy="229226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6969560"/>
            <a:ext cx="5157787" cy="1025117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4677291"/>
            <a:ext cx="5183188" cy="229226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6969560"/>
            <a:ext cx="5183188" cy="1025117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C96D-EB8A-4052-8474-F05DE77A4B07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6C88B-2928-4EEF-811F-F22292A73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858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C96D-EB8A-4052-8474-F05DE77A4B07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6C88B-2928-4EEF-811F-F22292A73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515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C96D-EB8A-4052-8474-F05DE77A4B07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6C88B-2928-4EEF-811F-F22292A73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695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272011"/>
            <a:ext cx="3932237" cy="4452038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747194"/>
            <a:ext cx="6172200" cy="13559283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724049"/>
            <a:ext cx="3932237" cy="1060450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C96D-EB8A-4052-8474-F05DE77A4B07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6C88B-2928-4EEF-811F-F22292A73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5081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272011"/>
            <a:ext cx="3932237" cy="4452038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747194"/>
            <a:ext cx="6172200" cy="13559283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724049"/>
            <a:ext cx="3932237" cy="1060450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C96D-EB8A-4052-8474-F05DE77A4B07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6C88B-2928-4EEF-811F-F22292A73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582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1015846"/>
            <a:ext cx="10515600" cy="36879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5079210"/>
            <a:ext cx="10515600" cy="1210618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7684489"/>
            <a:ext cx="2743200" cy="10158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CFC96D-EB8A-4052-8474-F05DE77A4B07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7684489"/>
            <a:ext cx="4114800" cy="10158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7684489"/>
            <a:ext cx="2743200" cy="10158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66C88B-2928-4EEF-811F-F22292A73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196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그룹 43">
            <a:extLst>
              <a:ext uri="{FF2B5EF4-FFF2-40B4-BE49-F238E27FC236}">
                <a16:creationId xmlns:a16="http://schemas.microsoft.com/office/drawing/2014/main" id="{A3BFE27C-956C-BDE6-34D4-9D424A46FFAA}"/>
              </a:ext>
            </a:extLst>
          </p:cNvPr>
          <p:cNvGrpSpPr/>
          <p:nvPr/>
        </p:nvGrpSpPr>
        <p:grpSpPr>
          <a:xfrm>
            <a:off x="6626261" y="93999"/>
            <a:ext cx="5010150" cy="14111965"/>
            <a:chOff x="6361568" y="0"/>
            <a:chExt cx="5010150" cy="14111965"/>
          </a:xfrm>
        </p:grpSpPr>
        <p:grpSp>
          <p:nvGrpSpPr>
            <p:cNvPr id="35" name="그룹 34">
              <a:extLst>
                <a:ext uri="{FF2B5EF4-FFF2-40B4-BE49-F238E27FC236}">
                  <a16:creationId xmlns:a16="http://schemas.microsoft.com/office/drawing/2014/main" id="{96A62F5E-27FE-F081-4694-82F65402B392}"/>
                </a:ext>
              </a:extLst>
            </p:cNvPr>
            <p:cNvGrpSpPr/>
            <p:nvPr/>
          </p:nvGrpSpPr>
          <p:grpSpPr>
            <a:xfrm>
              <a:off x="6361568" y="0"/>
              <a:ext cx="5010150" cy="3382923"/>
              <a:chOff x="5423105" y="1005947"/>
              <a:chExt cx="5010150" cy="3382923"/>
            </a:xfrm>
          </p:grpSpPr>
          <p:grpSp>
            <p:nvGrpSpPr>
              <p:cNvPr id="12" name="그룹 11">
                <a:extLst>
                  <a:ext uri="{FF2B5EF4-FFF2-40B4-BE49-F238E27FC236}">
                    <a16:creationId xmlns:a16="http://schemas.microsoft.com/office/drawing/2014/main" id="{A360583E-03FF-4276-E8DE-59A632B3B636}"/>
                  </a:ext>
                </a:extLst>
              </p:cNvPr>
              <p:cNvGrpSpPr/>
              <p:nvPr/>
            </p:nvGrpSpPr>
            <p:grpSpPr>
              <a:xfrm>
                <a:off x="5423105" y="1702820"/>
                <a:ext cx="5010150" cy="2686050"/>
                <a:chOff x="5010150" y="0"/>
                <a:chExt cx="5010150" cy="2686050"/>
              </a:xfrm>
            </p:grpSpPr>
            <p:pic>
              <p:nvPicPr>
                <p:cNvPr id="7" name="그림 6">
                  <a:extLst>
                    <a:ext uri="{FF2B5EF4-FFF2-40B4-BE49-F238E27FC236}">
                      <a16:creationId xmlns:a16="http://schemas.microsoft.com/office/drawing/2014/main" id="{1E254F05-E49E-B616-E87A-32F94E3B21F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4250"/>
                <a:stretch/>
              </p:blipFill>
              <p:spPr>
                <a:xfrm>
                  <a:off x="5010150" y="0"/>
                  <a:ext cx="5010150" cy="2686050"/>
                </a:xfrm>
                <a:prstGeom prst="rect">
                  <a:avLst/>
                </a:prstGeom>
              </p:spPr>
            </p:pic>
            <p:pic>
              <p:nvPicPr>
                <p:cNvPr id="11" name="그림 10">
                  <a:extLst>
                    <a:ext uri="{FF2B5EF4-FFF2-40B4-BE49-F238E27FC236}">
                      <a16:creationId xmlns:a16="http://schemas.microsoft.com/office/drawing/2014/main" id="{5AB10765-99D1-F442-3998-9FCA0C4D5B1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4002" r="47679"/>
                <a:stretch/>
              </p:blipFill>
              <p:spPr>
                <a:xfrm>
                  <a:off x="5010150" y="0"/>
                  <a:ext cx="1390650" cy="2686050"/>
                </a:xfrm>
                <a:prstGeom prst="rect">
                  <a:avLst/>
                </a:prstGeom>
              </p:spPr>
            </p:pic>
          </p:grp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8042F12E-C7AE-97D9-667B-6BBD56008322}"/>
                  </a:ext>
                </a:extLst>
              </p:cNvPr>
              <p:cNvSpPr txBox="1"/>
              <p:nvPr/>
            </p:nvSpPr>
            <p:spPr>
              <a:xfrm>
                <a:off x="5423105" y="1005947"/>
                <a:ext cx="4971370" cy="64633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/>
                  <a:t>Fxa6Bg1786860.m01- Fxa6Bg2100240.m01</a:t>
                </a:r>
              </a:p>
              <a:p>
                <a:r>
                  <a:rPr lang="en-US" b="1" dirty="0"/>
                  <a:t>Fxa6Bg1786870.m01- Fxa6Bg2100240.m01</a:t>
                </a:r>
              </a:p>
            </p:txBody>
          </p:sp>
        </p:grpSp>
        <p:grpSp>
          <p:nvGrpSpPr>
            <p:cNvPr id="37" name="그룹 36">
              <a:extLst>
                <a:ext uri="{FF2B5EF4-FFF2-40B4-BE49-F238E27FC236}">
                  <a16:creationId xmlns:a16="http://schemas.microsoft.com/office/drawing/2014/main" id="{711800F5-E63C-8751-C35B-8D4B900C0FEB}"/>
                </a:ext>
              </a:extLst>
            </p:cNvPr>
            <p:cNvGrpSpPr/>
            <p:nvPr/>
          </p:nvGrpSpPr>
          <p:grpSpPr>
            <a:xfrm>
              <a:off x="6361568" y="3877327"/>
              <a:ext cx="5010150" cy="3055382"/>
              <a:chOff x="5423105" y="5362563"/>
              <a:chExt cx="5010150" cy="3055382"/>
            </a:xfrm>
          </p:grpSpPr>
          <p:pic>
            <p:nvPicPr>
              <p:cNvPr id="16" name="그림 15">
                <a:extLst>
                  <a:ext uri="{FF2B5EF4-FFF2-40B4-BE49-F238E27FC236}">
                    <a16:creationId xmlns:a16="http://schemas.microsoft.com/office/drawing/2014/main" id="{25A5AD42-8CF7-8078-870B-578300C79E5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002"/>
              <a:stretch/>
            </p:blipFill>
            <p:spPr>
              <a:xfrm>
                <a:off x="5423105" y="5731895"/>
                <a:ext cx="5010150" cy="2686050"/>
              </a:xfrm>
              <a:prstGeom prst="rect">
                <a:avLst/>
              </a:prstGeom>
            </p:spPr>
          </p:pic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4D9391AA-951F-E1D9-7FA5-6C1E2FAABBC7}"/>
                  </a:ext>
                </a:extLst>
              </p:cNvPr>
              <p:cNvSpPr txBox="1"/>
              <p:nvPr/>
            </p:nvSpPr>
            <p:spPr>
              <a:xfrm>
                <a:off x="5423105" y="5362563"/>
                <a:ext cx="497137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/>
                  <a:t>Fxa6Bg1786920.m01- Fxa6Bg2100340.m01</a:t>
                </a:r>
              </a:p>
            </p:txBody>
          </p:sp>
        </p:grpSp>
        <p:grpSp>
          <p:nvGrpSpPr>
            <p:cNvPr id="39" name="그룹 38">
              <a:extLst>
                <a:ext uri="{FF2B5EF4-FFF2-40B4-BE49-F238E27FC236}">
                  <a16:creationId xmlns:a16="http://schemas.microsoft.com/office/drawing/2014/main" id="{E09B646F-36E9-9F2F-5EB8-7E1B59940832}"/>
                </a:ext>
              </a:extLst>
            </p:cNvPr>
            <p:cNvGrpSpPr/>
            <p:nvPr/>
          </p:nvGrpSpPr>
          <p:grpSpPr>
            <a:xfrm>
              <a:off x="6361568" y="7427113"/>
              <a:ext cx="5010150" cy="3131097"/>
              <a:chOff x="5423105" y="8997721"/>
              <a:chExt cx="5010150" cy="3131097"/>
            </a:xfrm>
          </p:grpSpPr>
          <p:pic>
            <p:nvPicPr>
              <p:cNvPr id="20" name="그림 19">
                <a:extLst>
                  <a:ext uri="{FF2B5EF4-FFF2-40B4-BE49-F238E27FC236}">
                    <a16:creationId xmlns:a16="http://schemas.microsoft.com/office/drawing/2014/main" id="{E27FD858-71B1-FD43-DA48-7C5EFE03E6D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250"/>
              <a:stretch/>
            </p:blipFill>
            <p:spPr>
              <a:xfrm>
                <a:off x="5423105" y="9442768"/>
                <a:ext cx="5010150" cy="2686050"/>
              </a:xfrm>
              <a:prstGeom prst="rect">
                <a:avLst/>
              </a:prstGeom>
            </p:spPr>
          </p:pic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174C8B2F-0148-6CFB-5FC6-E13B3AE298B8}"/>
                  </a:ext>
                </a:extLst>
              </p:cNvPr>
              <p:cNvSpPr txBox="1"/>
              <p:nvPr/>
            </p:nvSpPr>
            <p:spPr>
              <a:xfrm>
                <a:off x="5423105" y="8997721"/>
                <a:ext cx="497137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/>
                  <a:t>Fxa6Bg1786950.m01- Fxa6Bg2100380.m01</a:t>
                </a:r>
              </a:p>
            </p:txBody>
          </p:sp>
        </p:grpSp>
        <p:grpSp>
          <p:nvGrpSpPr>
            <p:cNvPr id="40" name="그룹 39">
              <a:extLst>
                <a:ext uri="{FF2B5EF4-FFF2-40B4-BE49-F238E27FC236}">
                  <a16:creationId xmlns:a16="http://schemas.microsoft.com/office/drawing/2014/main" id="{0AA5638F-B7BA-664F-6AD7-C3E939C0F38A}"/>
                </a:ext>
              </a:extLst>
            </p:cNvPr>
            <p:cNvGrpSpPr/>
            <p:nvPr/>
          </p:nvGrpSpPr>
          <p:grpSpPr>
            <a:xfrm>
              <a:off x="6361568" y="11052614"/>
              <a:ext cx="4971370" cy="3059351"/>
              <a:chOff x="5423105" y="12485767"/>
              <a:chExt cx="4971370" cy="3059351"/>
            </a:xfrm>
          </p:grpSpPr>
          <p:pic>
            <p:nvPicPr>
              <p:cNvPr id="22" name="그림 21">
                <a:extLst>
                  <a:ext uri="{FF2B5EF4-FFF2-40B4-BE49-F238E27FC236}">
                    <a16:creationId xmlns:a16="http://schemas.microsoft.com/office/drawing/2014/main" id="{410CD03E-A0FC-6A05-8CB1-376594EF5B0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513"/>
              <a:stretch/>
            </p:blipFill>
            <p:spPr>
              <a:xfrm>
                <a:off x="5423105" y="12859068"/>
                <a:ext cx="4971369" cy="2686050"/>
              </a:xfrm>
              <a:prstGeom prst="rect">
                <a:avLst/>
              </a:prstGeom>
            </p:spPr>
          </p:pic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28DBBE6D-A0EE-1F14-862E-738D8625309C}"/>
                  </a:ext>
                </a:extLst>
              </p:cNvPr>
              <p:cNvSpPr txBox="1"/>
              <p:nvPr/>
            </p:nvSpPr>
            <p:spPr>
              <a:xfrm>
                <a:off x="5423105" y="12485767"/>
                <a:ext cx="497137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/>
                  <a:t>Fxa6Bg1787000.m01- Fxa6Bg2100480.m01</a:t>
                </a:r>
              </a:p>
            </p:txBody>
          </p:sp>
        </p:grpSp>
      </p:grpSp>
      <p:grpSp>
        <p:nvGrpSpPr>
          <p:cNvPr id="43" name="그룹 42">
            <a:extLst>
              <a:ext uri="{FF2B5EF4-FFF2-40B4-BE49-F238E27FC236}">
                <a16:creationId xmlns:a16="http://schemas.microsoft.com/office/drawing/2014/main" id="{6DA3AFDF-6431-2334-D8AC-7A2A47CB7439}"/>
              </a:ext>
            </a:extLst>
          </p:cNvPr>
          <p:cNvGrpSpPr/>
          <p:nvPr/>
        </p:nvGrpSpPr>
        <p:grpSpPr>
          <a:xfrm>
            <a:off x="721893" y="93999"/>
            <a:ext cx="5022850" cy="17665125"/>
            <a:chOff x="938463" y="0"/>
            <a:chExt cx="5022850" cy="17665125"/>
          </a:xfrm>
        </p:grpSpPr>
        <p:grpSp>
          <p:nvGrpSpPr>
            <p:cNvPr id="34" name="그룹 33">
              <a:extLst>
                <a:ext uri="{FF2B5EF4-FFF2-40B4-BE49-F238E27FC236}">
                  <a16:creationId xmlns:a16="http://schemas.microsoft.com/office/drawing/2014/main" id="{119B6120-2DC4-B723-FCD3-ECD2E8A7B85F}"/>
                </a:ext>
              </a:extLst>
            </p:cNvPr>
            <p:cNvGrpSpPr/>
            <p:nvPr/>
          </p:nvGrpSpPr>
          <p:grpSpPr>
            <a:xfrm>
              <a:off x="938463" y="0"/>
              <a:ext cx="5010150" cy="3382923"/>
              <a:chOff x="0" y="1005947"/>
              <a:chExt cx="5010150" cy="3382923"/>
            </a:xfrm>
          </p:grpSpPr>
          <p:pic>
            <p:nvPicPr>
              <p:cNvPr id="9" name="그림 8">
                <a:extLst>
                  <a:ext uri="{FF2B5EF4-FFF2-40B4-BE49-F238E27FC236}">
                    <a16:creationId xmlns:a16="http://schemas.microsoft.com/office/drawing/2014/main" id="{24524647-3C40-1549-F7F8-D7CA9E45DEE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002"/>
              <a:stretch/>
            </p:blipFill>
            <p:spPr>
              <a:xfrm>
                <a:off x="0" y="1702820"/>
                <a:ext cx="5010150" cy="2686050"/>
              </a:xfrm>
              <a:prstGeom prst="rect">
                <a:avLst/>
              </a:prstGeom>
            </p:spPr>
          </p:pic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74C39269-D0A8-4B8D-F474-F0DF2CFC9C21}"/>
                  </a:ext>
                </a:extLst>
              </p:cNvPr>
              <p:cNvSpPr txBox="1"/>
              <p:nvPr/>
            </p:nvSpPr>
            <p:spPr>
              <a:xfrm>
                <a:off x="0" y="1005947"/>
                <a:ext cx="497137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/>
                  <a:t>Fxa6Bg1786850.m01- Fxa6Bg2100230.m01</a:t>
                </a:r>
              </a:p>
            </p:txBody>
          </p:sp>
        </p:grpSp>
        <p:grpSp>
          <p:nvGrpSpPr>
            <p:cNvPr id="36" name="그룹 35">
              <a:extLst>
                <a:ext uri="{FF2B5EF4-FFF2-40B4-BE49-F238E27FC236}">
                  <a16:creationId xmlns:a16="http://schemas.microsoft.com/office/drawing/2014/main" id="{E9C3D0F7-6803-CE7A-DE51-8C88187C7F10}"/>
                </a:ext>
              </a:extLst>
            </p:cNvPr>
            <p:cNvGrpSpPr/>
            <p:nvPr/>
          </p:nvGrpSpPr>
          <p:grpSpPr>
            <a:xfrm>
              <a:off x="938463" y="3877327"/>
              <a:ext cx="5010150" cy="3055382"/>
              <a:chOff x="0" y="5362563"/>
              <a:chExt cx="5010150" cy="3055382"/>
            </a:xfrm>
          </p:grpSpPr>
          <p:pic>
            <p:nvPicPr>
              <p:cNvPr id="14" name="그림 13">
                <a:extLst>
                  <a:ext uri="{FF2B5EF4-FFF2-40B4-BE49-F238E27FC236}">
                    <a16:creationId xmlns:a16="http://schemas.microsoft.com/office/drawing/2014/main" id="{BC80527A-3CC1-B2DF-CBAB-0F3A1622F1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002"/>
              <a:stretch/>
            </p:blipFill>
            <p:spPr>
              <a:xfrm>
                <a:off x="0" y="5731895"/>
                <a:ext cx="5010150" cy="2686050"/>
              </a:xfrm>
              <a:prstGeom prst="rect">
                <a:avLst/>
              </a:prstGeom>
            </p:spPr>
          </p:pic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A6890C65-AF82-0A2F-6339-CCAD49D099EA}"/>
                  </a:ext>
                </a:extLst>
              </p:cNvPr>
              <p:cNvSpPr txBox="1"/>
              <p:nvPr/>
            </p:nvSpPr>
            <p:spPr>
              <a:xfrm>
                <a:off x="0" y="5362563"/>
                <a:ext cx="497137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/>
                  <a:t>Fxa6Bg1786910.m01- Fxa6Bg2100330.m01</a:t>
                </a:r>
              </a:p>
            </p:txBody>
          </p:sp>
        </p:grpSp>
        <p:grpSp>
          <p:nvGrpSpPr>
            <p:cNvPr id="38" name="그룹 37">
              <a:extLst>
                <a:ext uri="{FF2B5EF4-FFF2-40B4-BE49-F238E27FC236}">
                  <a16:creationId xmlns:a16="http://schemas.microsoft.com/office/drawing/2014/main" id="{F5B79F94-2D54-6AB8-4305-20E3684C9E4F}"/>
                </a:ext>
              </a:extLst>
            </p:cNvPr>
            <p:cNvGrpSpPr/>
            <p:nvPr/>
          </p:nvGrpSpPr>
          <p:grpSpPr>
            <a:xfrm>
              <a:off x="938463" y="7427113"/>
              <a:ext cx="5010150" cy="3131097"/>
              <a:chOff x="0" y="8997721"/>
              <a:chExt cx="5010150" cy="3131097"/>
            </a:xfrm>
          </p:grpSpPr>
          <p:pic>
            <p:nvPicPr>
              <p:cNvPr id="18" name="그림 17">
                <a:extLst>
                  <a:ext uri="{FF2B5EF4-FFF2-40B4-BE49-F238E27FC236}">
                    <a16:creationId xmlns:a16="http://schemas.microsoft.com/office/drawing/2014/main" id="{1A2A3A00-5614-2D68-8DFC-13F43FAA901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250"/>
              <a:stretch/>
            </p:blipFill>
            <p:spPr>
              <a:xfrm>
                <a:off x="0" y="9442768"/>
                <a:ext cx="5010150" cy="2686050"/>
              </a:xfrm>
              <a:prstGeom prst="rect">
                <a:avLst/>
              </a:prstGeom>
            </p:spPr>
          </p:pic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93B960F3-5252-14C2-EB6B-A601CFBC4977}"/>
                  </a:ext>
                </a:extLst>
              </p:cNvPr>
              <p:cNvSpPr txBox="1"/>
              <p:nvPr/>
            </p:nvSpPr>
            <p:spPr>
              <a:xfrm>
                <a:off x="0" y="8997721"/>
                <a:ext cx="497137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/>
                  <a:t>Fxa6Bg1786940.m01- Fxa6Bg2100360.m01</a:t>
                </a:r>
              </a:p>
            </p:txBody>
          </p:sp>
        </p:grpSp>
        <p:grpSp>
          <p:nvGrpSpPr>
            <p:cNvPr id="41" name="그룹 40">
              <a:extLst>
                <a:ext uri="{FF2B5EF4-FFF2-40B4-BE49-F238E27FC236}">
                  <a16:creationId xmlns:a16="http://schemas.microsoft.com/office/drawing/2014/main" id="{EDA7BB48-70CE-6FA4-E3EE-386E353FB6E9}"/>
                </a:ext>
              </a:extLst>
            </p:cNvPr>
            <p:cNvGrpSpPr/>
            <p:nvPr/>
          </p:nvGrpSpPr>
          <p:grpSpPr>
            <a:xfrm>
              <a:off x="938463" y="11052614"/>
              <a:ext cx="4971370" cy="3059351"/>
              <a:chOff x="0" y="12485767"/>
              <a:chExt cx="4971370" cy="3059351"/>
            </a:xfrm>
          </p:grpSpPr>
          <p:pic>
            <p:nvPicPr>
              <p:cNvPr id="21" name="그림 20">
                <a:extLst>
                  <a:ext uri="{FF2B5EF4-FFF2-40B4-BE49-F238E27FC236}">
                    <a16:creationId xmlns:a16="http://schemas.microsoft.com/office/drawing/2014/main" id="{22A1E7AF-9514-42AB-E331-7CF65D9EDB0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513"/>
              <a:stretch/>
            </p:blipFill>
            <p:spPr>
              <a:xfrm>
                <a:off x="0" y="12859068"/>
                <a:ext cx="4971369" cy="2686050"/>
              </a:xfrm>
              <a:prstGeom prst="rect">
                <a:avLst/>
              </a:prstGeom>
            </p:spPr>
          </p:pic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6BA71E1D-C420-F64E-B082-DAA25F3B4945}"/>
                  </a:ext>
                </a:extLst>
              </p:cNvPr>
              <p:cNvSpPr txBox="1"/>
              <p:nvPr/>
            </p:nvSpPr>
            <p:spPr>
              <a:xfrm>
                <a:off x="0" y="12485767"/>
                <a:ext cx="497137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/>
                  <a:t>Fxa6Bg1786990.m01- Fxa6Bg2100470.m01</a:t>
                </a:r>
              </a:p>
            </p:txBody>
          </p:sp>
        </p:grpSp>
        <p:grpSp>
          <p:nvGrpSpPr>
            <p:cNvPr id="42" name="그룹 41">
              <a:extLst>
                <a:ext uri="{FF2B5EF4-FFF2-40B4-BE49-F238E27FC236}">
                  <a16:creationId xmlns:a16="http://schemas.microsoft.com/office/drawing/2014/main" id="{363E81F1-BC25-E7E4-FDCE-F6C695F1D78B}"/>
                </a:ext>
              </a:extLst>
            </p:cNvPr>
            <p:cNvGrpSpPr/>
            <p:nvPr/>
          </p:nvGrpSpPr>
          <p:grpSpPr>
            <a:xfrm>
              <a:off x="938463" y="14606370"/>
              <a:ext cx="5022850" cy="3058755"/>
              <a:chOff x="0" y="15925138"/>
              <a:chExt cx="5022850" cy="3058755"/>
            </a:xfrm>
          </p:grpSpPr>
          <p:pic>
            <p:nvPicPr>
              <p:cNvPr id="23" name="그림 22">
                <a:extLst>
                  <a:ext uri="{FF2B5EF4-FFF2-40B4-BE49-F238E27FC236}">
                    <a16:creationId xmlns:a16="http://schemas.microsoft.com/office/drawing/2014/main" id="{DF9448A1-4269-998F-1605-D32EF73D253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083"/>
              <a:stretch/>
            </p:blipFill>
            <p:spPr>
              <a:xfrm>
                <a:off x="0" y="16297843"/>
                <a:ext cx="5022850" cy="2686050"/>
              </a:xfrm>
              <a:prstGeom prst="rect">
                <a:avLst/>
              </a:prstGeom>
            </p:spPr>
          </p:pic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91A93765-29A4-B1A2-7BC7-222B7C17617C}"/>
                  </a:ext>
                </a:extLst>
              </p:cNvPr>
              <p:cNvSpPr txBox="1"/>
              <p:nvPr/>
            </p:nvSpPr>
            <p:spPr>
              <a:xfrm>
                <a:off x="0" y="15925138"/>
                <a:ext cx="497137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/>
                  <a:t>Fxa6Bg1787010.m01- Fxa6Bg2100490.m01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39163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3</TotalTime>
  <Words>60</Words>
  <Application>Microsoft Office PowerPoint</Application>
  <PresentationFormat>사용자 지정</PresentationFormat>
  <Paragraphs>1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Company>University of Flori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n, Hyeondae</dc:creator>
  <cp:lastModifiedBy>Han, Hyeondae</cp:lastModifiedBy>
  <cp:revision>4</cp:revision>
  <dcterms:created xsi:type="dcterms:W3CDTF">2024-07-23T07:37:24Z</dcterms:created>
  <dcterms:modified xsi:type="dcterms:W3CDTF">2024-08-09T02:38:36Z</dcterms:modified>
</cp:coreProperties>
</file>